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22200" y="696960"/>
            <a:ext cx="2614680" cy="348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416120"/>
            <a:ext cx="5029200" cy="418284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3116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83116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lstStyle>
            <a:lvl1pPr indent="0" algn="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fld id="{D5BB948C-F4E2-4B75-BFE2-C351FE68CE7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7"/>
          <p:cNvSpPr/>
          <p:nvPr/>
        </p:nvSpPr>
        <p:spPr>
          <a:xfrm>
            <a:off x="3886200" y="8831160"/>
            <a:ext cx="29718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080" bIns="46080" anchor="b">
            <a:noAutofit/>
          </a:bodyPr>
          <a:p>
            <a:pPr algn="r"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fld id="{1A7677E0-196A-4866-9B23-BCDE4D607E8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2122560" y="696960"/>
            <a:ext cx="2614680" cy="348624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914400" y="4416120"/>
            <a:ext cx="5029200" cy="4192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4B7E2-89BA-4E0C-B43B-6CEF48AB26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6264B-2034-499E-BE6C-88394D873A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41FDF-180F-47D6-A103-E5CAAA8798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7D99A-6B1E-44F1-B589-19B1E27E06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80589-1D6E-4CD9-95B6-75B7F21ACA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64360-9383-437F-9D15-E35B5485BB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D96DD-5B26-403C-945A-E732109277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DFE95-460A-4F4A-9655-8BB5A52F4D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A313A5-64E7-4D7C-B54E-AC50CD78C1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F8E02-19D3-4CBE-B5FB-441F8C6375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6EFE6-D568-45A2-B658-4093114F75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52B1C-6CB7-4553-84D3-D60417AB2F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7481BC-5CFA-4C9D-BFE6-AAE10EDD344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762120" y="101520"/>
            <a:ext cx="5043240" cy="747396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78000" y="7585920"/>
            <a:ext cx="64800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355680"/>
                <a:tab algn="l" pos="711360"/>
                <a:tab algn="l" pos="1066680"/>
                <a:tab algn="l" pos="1422360"/>
                <a:tab algn="l" pos="1778040"/>
                <a:tab algn="l" pos="2133720"/>
                <a:tab algn="l" pos="2489040"/>
                <a:tab algn="l" pos="2844720"/>
                <a:tab algn="l" pos="3200400"/>
                <a:tab algn="l" pos="3556080"/>
                <a:tab algn="l" pos="3911760"/>
                <a:tab algn="l" pos="426708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stogram of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-mer-association-with-RNAP for all 8-mers calculated for 13,861 common RNAP promoters between -1,000 bp and +500 bp; CpG containing 8-mers are noted in black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stogram of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-mer-association-with-H3K9me2 in keratinocytes for all 8-mers calculated for 14,790 promoters between -1,000 bp and +500 bp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-E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-mer-association-with-RNAP vs. 8-mer-association-with-H3K9me2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ll 8-mers,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8-mers without a CpG,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E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8-mers with a CpG.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Enrichment of 8-mers in 356 liver specific promoters vs. 8-mer-association-with-RNAP.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Clustering factor vs. 8-mer-association-with-RNA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4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ci</cp:lastModifiedBy>
  <cp:lastPrinted>2007-10-01T20:46:28Z</cp:lastPrinted>
  <dcterms:modified xsi:type="dcterms:W3CDTF">2008-01-21T03:29:47Z</dcterms:modified>
  <cp:revision>390</cp:revision>
  <dc:subject/>
  <dc:title>PowerPoint Presentation</dc:title>
</cp:coreProperties>
</file>